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2406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5424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0138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4423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0190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23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3435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5079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6519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1219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6774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FCA9C-6E4B-4C4D-A1E9-C584B02AB0AB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6AF3F-1DBC-4890-B21C-FFF8D1B1AC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9010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3404561"/>
              </p:ext>
            </p:extLst>
          </p:nvPr>
        </p:nvGraphicFramePr>
        <p:xfrm>
          <a:off x="188640" y="1229799"/>
          <a:ext cx="2799184" cy="47129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/>
                <a:gridCol w="741040"/>
                <a:gridCol w="782960"/>
                <a:gridCol w="513184"/>
              </a:tblGrid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Pro-MMP-2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414139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Relative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pixel</a:t>
                      </a:r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density</a:t>
                      </a:r>
                      <a:r>
                        <a:rPr lang="de-DE" sz="1000" u="none" strike="noStrike" dirty="0" smtClean="0">
                          <a:effectLst/>
                        </a:rPr>
                        <a:t>  Exp1 [AU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Relative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baseline="0" dirty="0" err="1" smtClean="0">
                          <a:effectLst/>
                        </a:rPr>
                        <a:t>p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ixel</a:t>
                      </a:r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density</a:t>
                      </a:r>
                      <a:r>
                        <a:rPr lang="de-DE" sz="1000" u="none" strike="noStrike" dirty="0" smtClean="0">
                          <a:effectLst/>
                        </a:rPr>
                        <a:t>  Exp2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smtClean="0">
                          <a:effectLst/>
                        </a:rPr>
                        <a:t>[AU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Relative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baseline="0" dirty="0" err="1" smtClean="0">
                          <a:effectLst/>
                        </a:rPr>
                        <a:t>p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ixel</a:t>
                      </a:r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density</a:t>
                      </a:r>
                      <a:r>
                        <a:rPr lang="de-DE" sz="1000" u="none" strike="noStrike" dirty="0" smtClean="0">
                          <a:effectLst/>
                        </a:rPr>
                        <a:t> Exp3 [AU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Average [AU]</a:t>
                      </a:r>
                    </a:p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36004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8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9.6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9.9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82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01.9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2.7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7.8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80.8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70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83.3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6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6.7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9.3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9.0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89.0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9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44.9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2.7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5.1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0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8.5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9.3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5.5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4.5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1.7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1.5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6.6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6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4.1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9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3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2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0.9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7.8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9.8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09.5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13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8.8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1.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61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78.6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7.6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4.7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0.3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9.5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5.5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3.2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6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5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4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0.0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3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9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8.4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7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8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2.2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01.7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4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02.7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7.2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6.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97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0.6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95.1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4.2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66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68.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8.9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92.7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0.1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7.2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2.0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0.0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6.0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2.6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7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04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5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2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7.8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8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6.6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7.6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1.2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18.4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35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8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1.8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86.2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02.2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83.4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0.9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3.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71.9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8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5882655"/>
              </p:ext>
            </p:extLst>
          </p:nvPr>
        </p:nvGraphicFramePr>
        <p:xfrm>
          <a:off x="3111488" y="1226469"/>
          <a:ext cx="2871192" cy="47129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/>
                <a:gridCol w="762000"/>
                <a:gridCol w="762000"/>
                <a:gridCol w="585192"/>
              </a:tblGrid>
              <a:tr h="161925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 err="1">
                          <a:effectLst/>
                        </a:rPr>
                        <a:t>Active</a:t>
                      </a:r>
                      <a:r>
                        <a:rPr lang="de-DE" sz="1000" b="1" u="none" strike="noStrike" dirty="0">
                          <a:effectLst/>
                        </a:rPr>
                        <a:t> MMP-2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458207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Relative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baseline="0" dirty="0" err="1" smtClean="0">
                          <a:effectLst/>
                        </a:rPr>
                        <a:t>p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ixel</a:t>
                      </a:r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density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smtClean="0">
                          <a:effectLst/>
                        </a:rPr>
                        <a:t>Exp1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smtClean="0">
                          <a:effectLst/>
                        </a:rPr>
                        <a:t>[AU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Relative</a:t>
                      </a:r>
                      <a:r>
                        <a:rPr lang="de-DE" sz="10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000" u="none" strike="noStrike" baseline="0" dirty="0" err="1" smtClean="0">
                          <a:effectLst/>
                        </a:rPr>
                        <a:t>p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ixel</a:t>
                      </a:r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density</a:t>
                      </a:r>
                      <a:r>
                        <a:rPr lang="de-DE" sz="1000" u="none" strike="noStrike" dirty="0" smtClean="0">
                          <a:effectLst/>
                        </a:rPr>
                        <a:t> Exp2 [AU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Relative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pixel</a:t>
                      </a:r>
                      <a:r>
                        <a:rPr lang="de-DE" sz="1000" u="none" strike="noStrike" dirty="0" smtClean="0">
                          <a:effectLst/>
                        </a:rPr>
                        <a:t> </a:t>
                      </a:r>
                      <a:r>
                        <a:rPr lang="de-DE" sz="1000" u="none" strike="noStrike" dirty="0" err="1" smtClean="0">
                          <a:effectLst/>
                        </a:rPr>
                        <a:t>density</a:t>
                      </a:r>
                      <a:r>
                        <a:rPr lang="de-DE" sz="1000" u="none" strike="noStrike" dirty="0" smtClean="0">
                          <a:effectLst/>
                        </a:rPr>
                        <a:t> Exp3 [AU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 smtClean="0">
                          <a:effectLst/>
                        </a:rPr>
                        <a:t>Average [AU]</a:t>
                      </a:r>
                    </a:p>
                  </a:txBody>
                  <a:tcPr marL="9525" marR="9525" marT="9525" marB="0" anchor="b"/>
                </a:tc>
              </a:tr>
              <a:tr h="36004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2.4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4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2.7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7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2.3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9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7.6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3.1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6.1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.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5.4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0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1.5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9.3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7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7.3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4.9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2.2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8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6.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5.9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3.9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8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9.2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4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5.8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6.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8.8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0.7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8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7.9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7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.2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4.4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3.9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1.7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6.7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4.7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5.2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3.3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1.1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2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2.6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8.3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7.8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64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1.9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5.4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0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5.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4.2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3.3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4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7.0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8.6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.2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5.9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2.1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6.2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3.2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0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1.3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9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52.3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4.5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9.6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4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9.4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8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8.7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.2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7.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9.3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0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.6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5.5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7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46.8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2.4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6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5.2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2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6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6.9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2.0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7.4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0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30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.8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22.3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.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5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smtClean="0">
                          <a:effectLst/>
                        </a:rPr>
                        <a:t>18.7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188640" y="539552"/>
            <a:ext cx="73532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Table.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-2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sitie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erag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-MMP-2.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MP-2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otal MMP-2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ixel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siti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scrib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material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3131748"/>
              </p:ext>
            </p:extLst>
          </p:nvPr>
        </p:nvGraphicFramePr>
        <p:xfrm>
          <a:off x="6084168" y="1233696"/>
          <a:ext cx="2459487" cy="47042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0666"/>
                <a:gridCol w="938155"/>
                <a:gridCol w="760666"/>
              </a:tblGrid>
              <a:tr h="1616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Total MMP-2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484925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>
                          <a:effectLst/>
                        </a:rPr>
                        <a:t>Average </a:t>
                      </a:r>
                      <a:r>
                        <a:rPr lang="de-DE" sz="1000" u="none" strike="noStrike" dirty="0" smtClean="0">
                          <a:effectLst/>
                        </a:rPr>
                        <a:t>pro-MMP-2 [AU]</a:t>
                      </a: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>
                          <a:effectLst/>
                        </a:rPr>
                        <a:t>Average </a:t>
                      </a:r>
                      <a:r>
                        <a:rPr lang="de-DE" sz="1000" u="none" strike="noStrike" dirty="0" err="1">
                          <a:effectLst/>
                        </a:rPr>
                        <a:t>active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smtClean="0">
                          <a:effectLst/>
                        </a:rPr>
                        <a:t>MMP-2 [AU]</a:t>
                      </a: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u="none" strike="noStrike" dirty="0">
                          <a:effectLst/>
                        </a:rPr>
                        <a:t>Total </a:t>
                      </a:r>
                      <a:r>
                        <a:rPr lang="de-DE" sz="1000" u="none" strike="noStrike" dirty="0" smtClean="0">
                          <a:effectLst/>
                        </a:rPr>
                        <a:t>MMP-2 [AU]</a:t>
                      </a:r>
                    </a:p>
                  </a:txBody>
                  <a:tcPr marL="9508" marR="9508" marT="9508" marB="0" anchor="b"/>
                </a:tc>
              </a:tr>
              <a:tr h="333571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82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9.7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2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80.8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3.1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13.9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16.7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.3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39.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99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7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6.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80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8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9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34.5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8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83.1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66.6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6.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03.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2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9.8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2.0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09.5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9.6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1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6.7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98.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0.3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1.1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91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16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7.8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3.9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3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50.4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03.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8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4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2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02.7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5.9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8.7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80.6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50.5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31.1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8.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4.5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13.1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17.2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8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45.3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32.6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9.3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2.0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32.3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7.1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9.4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57.6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5.2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82.8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28.4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2.0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0.4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83.4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2.8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06.2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  <a:tr h="161642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68.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8.7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87.54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08" marR="9508" marT="9508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0920525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0</Words>
  <Application>Microsoft Office PowerPoint</Application>
  <PresentationFormat>Bildschirmpräsentation (4:3)</PresentationFormat>
  <Paragraphs>28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32:11Z</dcterms:created>
  <dcterms:modified xsi:type="dcterms:W3CDTF">2016-09-29T14:32:31Z</dcterms:modified>
</cp:coreProperties>
</file>